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Cryobiopsy</a:t>
            </a: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Outside of the Operating Room:</a:t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 Safe Alternative to Surgical Biopsy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POPULA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tients with suspected interstitial lung disease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quiring biopsy</a:t>
              </a:r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gh surgical risk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itical care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ngerous transportation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edside transbronchial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ng </a:t>
              </a:r>
              <a:r>
                <a:rPr lang="en-US" sz="2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yobiopsy</a:t>
              </a:r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ided treatment in 71%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% agreement between histologic &amp; final diagnosis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775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1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nezes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September/October 2021.</a:t>
              </a:r>
            </a:p>
          </p:txBody>
        </p:sp>
      </p:grpSp>
      <p:pic>
        <p:nvPicPr>
          <p:cNvPr id="13" name="Picture 12" descr="Captura de Tela 2020-12-09 às 3.34.17 PM.png">
            <a:extLst>
              <a:ext uri="{FF2B5EF4-FFF2-40B4-BE49-F238E27FC236}">
                <a16:creationId xmlns:a16="http://schemas.microsoft.com/office/drawing/2014/main" id="{B2528F2C-024B-46D3-B62D-D5EE95A4687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" t="1" r="887" b="2009"/>
          <a:stretch/>
        </p:blipFill>
        <p:spPr>
          <a:xfrm>
            <a:off x="8458661" y="2581476"/>
            <a:ext cx="3036570" cy="2122878"/>
          </a:xfrm>
          <a:prstGeom prst="rect">
            <a:avLst/>
          </a:prstGeom>
        </p:spPr>
      </p:pic>
      <p:pic>
        <p:nvPicPr>
          <p:cNvPr id="16" name="Picture 15" descr="Captura de Tela 2020-12-09 às 3.08.18 PM.png">
            <a:extLst>
              <a:ext uri="{FF2B5EF4-FFF2-40B4-BE49-F238E27FC236}">
                <a16:creationId xmlns:a16="http://schemas.microsoft.com/office/drawing/2014/main" id="{9C724C48-3B69-412D-91FD-EA2065A9C85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83" b="599"/>
          <a:stretch/>
        </p:blipFill>
        <p:spPr>
          <a:xfrm>
            <a:off x="4581803" y="2173527"/>
            <a:ext cx="3032482" cy="2530827"/>
          </a:xfrm>
          <a:prstGeom prst="rect">
            <a:avLst/>
          </a:prstGeom>
        </p:spPr>
      </p:pic>
      <p:pic>
        <p:nvPicPr>
          <p:cNvPr id="19" name="Graphic 18" descr="Lungs with solid fill">
            <a:extLst>
              <a:ext uri="{FF2B5EF4-FFF2-40B4-BE49-F238E27FC236}">
                <a16:creationId xmlns:a16="http://schemas.microsoft.com/office/drawing/2014/main" id="{3CBB46E0-2E0D-4831-A48F-F57AB82753C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627238" y="3197940"/>
            <a:ext cx="1177413" cy="1177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85</Words>
  <Application>Microsoft Office PowerPoint</Application>
  <PresentationFormat>Widescreen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Lung Cryobiopsy Outside of the Operating Room: A Safe Alternative to Surgical Biops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Holmes, Sari</cp:lastModifiedBy>
  <cp:revision>19</cp:revision>
  <dcterms:created xsi:type="dcterms:W3CDTF">2019-04-26T22:59:25Z</dcterms:created>
  <dcterms:modified xsi:type="dcterms:W3CDTF">2021-07-06T19:07:48Z</dcterms:modified>
</cp:coreProperties>
</file>